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42"/>
    <p:restoredTop sz="94685"/>
  </p:normalViewPr>
  <p:slideViewPr>
    <p:cSldViewPr snapToGrid="0" snapToObjects="1">
      <p:cViewPr varScale="1">
        <p:scale>
          <a:sx n="142" d="100"/>
          <a:sy n="142" d="100"/>
        </p:scale>
        <p:origin x="20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EBB96-8379-664D-9459-8BB41F9A80F5}" type="datetimeFigureOut">
              <a:rPr lang="en-US" smtClean="0"/>
              <a:t>4/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8DC83-2554-B541-85BD-04B042852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46939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EBB96-8379-664D-9459-8BB41F9A80F5}" type="datetimeFigureOut">
              <a:rPr lang="en-US" smtClean="0"/>
              <a:t>4/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8DC83-2554-B541-85BD-04B042852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42119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EBB96-8379-664D-9459-8BB41F9A80F5}" type="datetimeFigureOut">
              <a:rPr lang="en-US" smtClean="0"/>
              <a:t>4/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8DC83-2554-B541-85BD-04B042852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98048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EBB96-8379-664D-9459-8BB41F9A80F5}" type="datetimeFigureOut">
              <a:rPr lang="en-US" smtClean="0"/>
              <a:t>4/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8DC83-2554-B541-85BD-04B042852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90813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EBB96-8379-664D-9459-8BB41F9A80F5}" type="datetimeFigureOut">
              <a:rPr lang="en-US" smtClean="0"/>
              <a:t>4/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8DC83-2554-B541-85BD-04B042852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26185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EBB96-8379-664D-9459-8BB41F9A80F5}" type="datetimeFigureOut">
              <a:rPr lang="en-US" smtClean="0"/>
              <a:t>4/9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8DC83-2554-B541-85BD-04B042852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15518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EBB96-8379-664D-9459-8BB41F9A80F5}" type="datetimeFigureOut">
              <a:rPr lang="en-US" smtClean="0"/>
              <a:t>4/9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8DC83-2554-B541-85BD-04B042852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24922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EBB96-8379-664D-9459-8BB41F9A80F5}" type="datetimeFigureOut">
              <a:rPr lang="en-US" smtClean="0"/>
              <a:t>4/9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8DC83-2554-B541-85BD-04B042852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55062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EBB96-8379-664D-9459-8BB41F9A80F5}" type="datetimeFigureOut">
              <a:rPr lang="en-US" smtClean="0"/>
              <a:t>4/9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8DC83-2554-B541-85BD-04B042852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00315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EBB96-8379-664D-9459-8BB41F9A80F5}" type="datetimeFigureOut">
              <a:rPr lang="en-US" smtClean="0"/>
              <a:t>4/9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8DC83-2554-B541-85BD-04B042852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4611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8EBB96-8379-664D-9459-8BB41F9A80F5}" type="datetimeFigureOut">
              <a:rPr lang="en-US" smtClean="0"/>
              <a:t>4/9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8DC83-2554-B541-85BD-04B042852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55030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8EBB96-8379-664D-9459-8BB41F9A80F5}" type="datetimeFigureOut">
              <a:rPr lang="en-US" smtClean="0"/>
              <a:t>4/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88DC83-2554-B541-85BD-04B042852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14665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221226" y="77875"/>
            <a:ext cx="1197077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u="sng" dirty="0" smtClean="0"/>
              <a:t>Supplementary Figure </a:t>
            </a:r>
            <a:r>
              <a:rPr lang="en-US" u="sng" dirty="0" smtClean="0"/>
              <a:t>5-</a:t>
            </a:r>
            <a:r>
              <a:rPr lang="en-US" dirty="0"/>
              <a:t> Bacterial Cytological Profiling of △</a:t>
            </a:r>
            <a:r>
              <a:rPr lang="en-US" i="1" dirty="0" err="1"/>
              <a:t>tolC</a:t>
            </a:r>
            <a:r>
              <a:rPr lang="en-US" dirty="0"/>
              <a:t> </a:t>
            </a:r>
            <a:r>
              <a:rPr lang="en-US" i="1" dirty="0"/>
              <a:t>E.coli</a:t>
            </a:r>
            <a:r>
              <a:rPr lang="en-US" dirty="0"/>
              <a:t> treated </a:t>
            </a:r>
            <a:r>
              <a:rPr lang="en-US" dirty="0" smtClean="0"/>
              <a:t>with known </a:t>
            </a:r>
            <a:r>
              <a:rPr lang="en-US" dirty="0"/>
              <a:t>antibiotic compounds on cheese curd </a:t>
            </a:r>
            <a:r>
              <a:rPr lang="en-US" dirty="0" smtClean="0"/>
              <a:t>agar</a:t>
            </a:r>
            <a:r>
              <a:rPr lang="en-US" dirty="0"/>
              <a:t>.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3038" y="741405"/>
            <a:ext cx="11487150" cy="59803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725704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0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Calibri Light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33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mily C Pierce</dc:creator>
  <cp:lastModifiedBy>Emily C Pierce</cp:lastModifiedBy>
  <cp:revision>5</cp:revision>
  <dcterms:created xsi:type="dcterms:W3CDTF">2020-04-09T22:28:48Z</dcterms:created>
  <dcterms:modified xsi:type="dcterms:W3CDTF">2020-04-09T22:32:30Z</dcterms:modified>
</cp:coreProperties>
</file>